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wmf" ContentType="image/x-wmf"/>
  <Override PartName="/ppt/media/image13.wmf" ContentType="image/x-wmf"/>
  <Override PartName="/ppt/media/image8.wmf" ContentType="image/x-wmf"/>
  <Override PartName="/ppt/media/image12.wmf" ContentType="image/x-wmf"/>
  <Override PartName="/ppt/media/image7.wmf" ContentType="image/x-wmf"/>
  <Override PartName="/ppt/media/image11.wmf" ContentType="image/x-wmf"/>
  <Override PartName="/ppt/media/image6.wmf" ContentType="image/x-wmf"/>
  <Override PartName="/ppt/media/image10.wmf" ContentType="image/x-wmf"/>
  <Override PartName="/ppt/media/image4.wmf" ContentType="image/x-wmf"/>
  <Override PartName="/ppt/media/image21.wmf" ContentType="image/x-wmf"/>
  <Override PartName="/ppt/media/image19.wmf" ContentType="image/x-wmf"/>
  <Override PartName="/ppt/media/image1.wmf" ContentType="image/x-wmf"/>
  <Override PartName="/ppt/media/image3.wmf" ContentType="image/x-wmf"/>
  <Override PartName="/ppt/media/image20.wmf" ContentType="image/x-wmf"/>
  <Override PartName="/ppt/media/image18.wmf" ContentType="image/x-wmf"/>
  <Override PartName="/ppt/media/image17.wmf" ContentType="image/x-wmf"/>
  <Override PartName="/ppt/media/image16.wmf" ContentType="image/x-wmf"/>
  <Override PartName="/ppt/media/image15.wmf" ContentType="image/x-wmf"/>
  <Override PartName="/ppt/media/image14.wmf" ContentType="image/x-wmf"/>
  <Override PartName="/ppt/media/image2.wmf" ContentType="image/x-wmf"/>
  <Override PartName="/ppt/media/image5.wmf" ContentType="image/x-wmf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</p:sldIdLst>
  <p:sldSz cx="7099300" cy="9947275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EC0D70-D558-450E-AFC9-DADAA83CCD8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55320" y="398520"/>
            <a:ext cx="6388200" cy="1657440"/>
          </a:xfrm>
          <a:prstGeom prst="rect">
            <a:avLst/>
          </a:prstGeom>
          <a:noFill/>
          <a:ln w="0">
            <a:noFill/>
          </a:ln>
        </p:spPr>
        <p:txBody>
          <a:bodyPr lIns="52560" rIns="52560" tIns="26280" bIns="2628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55320" y="2320920"/>
            <a:ext cx="6388200" cy="3130200"/>
          </a:xfrm>
          <a:prstGeom prst="rect">
            <a:avLst/>
          </a:prstGeom>
          <a:noFill/>
          <a:ln w="0">
            <a:noFill/>
          </a:ln>
        </p:spPr>
        <p:txBody>
          <a:bodyPr lIns="52560" rIns="52560" tIns="26280" bIns="26280"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55320" y="5748840"/>
            <a:ext cx="6388200" cy="3130200"/>
          </a:xfrm>
          <a:prstGeom prst="rect">
            <a:avLst/>
          </a:prstGeom>
          <a:noFill/>
          <a:ln w="0">
            <a:noFill/>
          </a:ln>
        </p:spPr>
        <p:txBody>
          <a:bodyPr lIns="52560" rIns="52560" tIns="26280" bIns="26280"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972C52-5479-4BF1-B21D-D52AFABDDE3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55320" y="398520"/>
            <a:ext cx="6388200" cy="1657440"/>
          </a:xfrm>
          <a:prstGeom prst="rect">
            <a:avLst/>
          </a:prstGeom>
          <a:noFill/>
          <a:ln w="0">
            <a:noFill/>
          </a:ln>
        </p:spPr>
        <p:txBody>
          <a:bodyPr lIns="52560" rIns="52560" tIns="26280" bIns="2628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55320" y="2320920"/>
            <a:ext cx="3117240" cy="3130200"/>
          </a:xfrm>
          <a:prstGeom prst="rect">
            <a:avLst/>
          </a:prstGeom>
          <a:noFill/>
          <a:ln w="0">
            <a:noFill/>
          </a:ln>
        </p:spPr>
        <p:txBody>
          <a:bodyPr lIns="52560" rIns="52560" tIns="26280" bIns="26280"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628800" y="2320920"/>
            <a:ext cx="3117240" cy="3130200"/>
          </a:xfrm>
          <a:prstGeom prst="rect">
            <a:avLst/>
          </a:prstGeom>
          <a:noFill/>
          <a:ln w="0">
            <a:noFill/>
          </a:ln>
        </p:spPr>
        <p:txBody>
          <a:bodyPr lIns="52560" rIns="52560" tIns="26280" bIns="26280"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55320" y="5748840"/>
            <a:ext cx="3117240" cy="3130200"/>
          </a:xfrm>
          <a:prstGeom prst="rect">
            <a:avLst/>
          </a:prstGeom>
          <a:noFill/>
          <a:ln w="0">
            <a:noFill/>
          </a:ln>
        </p:spPr>
        <p:txBody>
          <a:bodyPr lIns="52560" rIns="52560" tIns="26280" bIns="26280"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628800" y="5748840"/>
            <a:ext cx="3117240" cy="3130200"/>
          </a:xfrm>
          <a:prstGeom prst="rect">
            <a:avLst/>
          </a:prstGeom>
          <a:noFill/>
          <a:ln w="0">
            <a:noFill/>
          </a:ln>
        </p:spPr>
        <p:txBody>
          <a:bodyPr lIns="52560" rIns="52560" tIns="26280" bIns="26280"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3B8EE2-294C-4132-9C9D-8B73139B6E7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55320" y="398520"/>
            <a:ext cx="6388200" cy="1657440"/>
          </a:xfrm>
          <a:prstGeom prst="rect">
            <a:avLst/>
          </a:prstGeom>
          <a:noFill/>
          <a:ln w="0">
            <a:noFill/>
          </a:ln>
        </p:spPr>
        <p:txBody>
          <a:bodyPr lIns="52560" rIns="52560" tIns="26280" bIns="2628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55320" y="2320920"/>
            <a:ext cx="2056680" cy="3130200"/>
          </a:xfrm>
          <a:prstGeom prst="rect">
            <a:avLst/>
          </a:prstGeom>
          <a:noFill/>
          <a:ln w="0">
            <a:noFill/>
          </a:ln>
        </p:spPr>
        <p:txBody>
          <a:bodyPr lIns="52560" rIns="52560" tIns="26280" bIns="26280"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515320" y="2320920"/>
            <a:ext cx="2056680" cy="3130200"/>
          </a:xfrm>
          <a:prstGeom prst="rect">
            <a:avLst/>
          </a:prstGeom>
          <a:noFill/>
          <a:ln w="0">
            <a:noFill/>
          </a:ln>
        </p:spPr>
        <p:txBody>
          <a:bodyPr lIns="52560" rIns="52560" tIns="26280" bIns="26280"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674960" y="2320920"/>
            <a:ext cx="2056680" cy="3130200"/>
          </a:xfrm>
          <a:prstGeom prst="rect">
            <a:avLst/>
          </a:prstGeom>
          <a:noFill/>
          <a:ln w="0">
            <a:noFill/>
          </a:ln>
        </p:spPr>
        <p:txBody>
          <a:bodyPr lIns="52560" rIns="52560" tIns="26280" bIns="26280"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55320" y="5748840"/>
            <a:ext cx="2056680" cy="3130200"/>
          </a:xfrm>
          <a:prstGeom prst="rect">
            <a:avLst/>
          </a:prstGeom>
          <a:noFill/>
          <a:ln w="0">
            <a:noFill/>
          </a:ln>
        </p:spPr>
        <p:txBody>
          <a:bodyPr lIns="52560" rIns="52560" tIns="26280" bIns="26280"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515320" y="5748840"/>
            <a:ext cx="2056680" cy="3130200"/>
          </a:xfrm>
          <a:prstGeom prst="rect">
            <a:avLst/>
          </a:prstGeom>
          <a:noFill/>
          <a:ln w="0">
            <a:noFill/>
          </a:ln>
        </p:spPr>
        <p:txBody>
          <a:bodyPr lIns="52560" rIns="52560" tIns="26280" bIns="26280"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674960" y="5748840"/>
            <a:ext cx="2056680" cy="3130200"/>
          </a:xfrm>
          <a:prstGeom prst="rect">
            <a:avLst/>
          </a:prstGeom>
          <a:noFill/>
          <a:ln w="0">
            <a:noFill/>
          </a:ln>
        </p:spPr>
        <p:txBody>
          <a:bodyPr lIns="52560" rIns="52560" tIns="26280" bIns="26280"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904369-37B9-44A4-9793-57A753586AC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55320" y="398520"/>
            <a:ext cx="6388200" cy="1657440"/>
          </a:xfrm>
          <a:prstGeom prst="rect">
            <a:avLst/>
          </a:prstGeom>
          <a:noFill/>
          <a:ln w="0">
            <a:noFill/>
          </a:ln>
        </p:spPr>
        <p:txBody>
          <a:bodyPr lIns="52560" rIns="52560" tIns="26280" bIns="2628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55320" y="2320920"/>
            <a:ext cx="6388200" cy="6562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624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2FA0E11-4D1A-4F24-B73E-5452C37D704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55320" y="398520"/>
            <a:ext cx="6388200" cy="1657440"/>
          </a:xfrm>
          <a:prstGeom prst="rect">
            <a:avLst/>
          </a:prstGeom>
          <a:noFill/>
          <a:ln w="0">
            <a:noFill/>
          </a:ln>
        </p:spPr>
        <p:txBody>
          <a:bodyPr lIns="52560" rIns="52560" tIns="26280" bIns="2628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55320" y="2320920"/>
            <a:ext cx="6388200" cy="6562800"/>
          </a:xfrm>
          <a:prstGeom prst="rect">
            <a:avLst/>
          </a:prstGeom>
          <a:noFill/>
          <a:ln w="0">
            <a:noFill/>
          </a:ln>
        </p:spPr>
        <p:txBody>
          <a:bodyPr lIns="52560" rIns="52560" tIns="26280" bIns="26280"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16557F-92D4-4F24-AF10-8DD9FBCDD66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55320" y="398520"/>
            <a:ext cx="6388200" cy="1657440"/>
          </a:xfrm>
          <a:prstGeom prst="rect">
            <a:avLst/>
          </a:prstGeom>
          <a:noFill/>
          <a:ln w="0">
            <a:noFill/>
          </a:ln>
        </p:spPr>
        <p:txBody>
          <a:bodyPr lIns="52560" rIns="52560" tIns="26280" bIns="2628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55320" y="2320920"/>
            <a:ext cx="3117240" cy="6562800"/>
          </a:xfrm>
          <a:prstGeom prst="rect">
            <a:avLst/>
          </a:prstGeom>
          <a:noFill/>
          <a:ln w="0">
            <a:noFill/>
          </a:ln>
        </p:spPr>
        <p:txBody>
          <a:bodyPr lIns="52560" rIns="52560" tIns="26280" bIns="26280"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628800" y="2320920"/>
            <a:ext cx="3117240" cy="6562800"/>
          </a:xfrm>
          <a:prstGeom prst="rect">
            <a:avLst/>
          </a:prstGeom>
          <a:noFill/>
          <a:ln w="0">
            <a:noFill/>
          </a:ln>
        </p:spPr>
        <p:txBody>
          <a:bodyPr lIns="52560" rIns="52560" tIns="26280" bIns="26280"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FCC430-A80C-487A-BB27-1D4A940E489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55320" y="398520"/>
            <a:ext cx="6388200" cy="1657440"/>
          </a:xfrm>
          <a:prstGeom prst="rect">
            <a:avLst/>
          </a:prstGeom>
          <a:noFill/>
          <a:ln w="0">
            <a:noFill/>
          </a:ln>
        </p:spPr>
        <p:txBody>
          <a:bodyPr lIns="52560" rIns="52560" tIns="26280" bIns="2628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73EB23-69F5-448B-B418-2B70540EA69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55320" y="398520"/>
            <a:ext cx="6388200" cy="7684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6F191A-9EDF-4B3F-9CBA-091F4F5A4F8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55320" y="398520"/>
            <a:ext cx="6388200" cy="1657440"/>
          </a:xfrm>
          <a:prstGeom prst="rect">
            <a:avLst/>
          </a:prstGeom>
          <a:noFill/>
          <a:ln w="0">
            <a:noFill/>
          </a:ln>
        </p:spPr>
        <p:txBody>
          <a:bodyPr lIns="52560" rIns="52560" tIns="26280" bIns="2628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55320" y="2320920"/>
            <a:ext cx="3117240" cy="3130200"/>
          </a:xfrm>
          <a:prstGeom prst="rect">
            <a:avLst/>
          </a:prstGeom>
          <a:noFill/>
          <a:ln w="0">
            <a:noFill/>
          </a:ln>
        </p:spPr>
        <p:txBody>
          <a:bodyPr lIns="52560" rIns="52560" tIns="26280" bIns="26280"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628800" y="2320920"/>
            <a:ext cx="3117240" cy="6562800"/>
          </a:xfrm>
          <a:prstGeom prst="rect">
            <a:avLst/>
          </a:prstGeom>
          <a:noFill/>
          <a:ln w="0">
            <a:noFill/>
          </a:ln>
        </p:spPr>
        <p:txBody>
          <a:bodyPr lIns="52560" rIns="52560" tIns="26280" bIns="26280"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55320" y="5748840"/>
            <a:ext cx="3117240" cy="3130200"/>
          </a:xfrm>
          <a:prstGeom prst="rect">
            <a:avLst/>
          </a:prstGeom>
          <a:noFill/>
          <a:ln w="0">
            <a:noFill/>
          </a:ln>
        </p:spPr>
        <p:txBody>
          <a:bodyPr lIns="52560" rIns="52560" tIns="26280" bIns="26280"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58624A1-754E-4636-83EA-53AC21511E6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55320" y="398520"/>
            <a:ext cx="6388200" cy="1657440"/>
          </a:xfrm>
          <a:prstGeom prst="rect">
            <a:avLst/>
          </a:prstGeom>
          <a:noFill/>
          <a:ln w="0">
            <a:noFill/>
          </a:ln>
        </p:spPr>
        <p:txBody>
          <a:bodyPr lIns="52560" rIns="52560" tIns="26280" bIns="2628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55320" y="2320920"/>
            <a:ext cx="3117240" cy="6562800"/>
          </a:xfrm>
          <a:prstGeom prst="rect">
            <a:avLst/>
          </a:prstGeom>
          <a:noFill/>
          <a:ln w="0">
            <a:noFill/>
          </a:ln>
        </p:spPr>
        <p:txBody>
          <a:bodyPr lIns="52560" rIns="52560" tIns="26280" bIns="26280"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628800" y="2320920"/>
            <a:ext cx="3117240" cy="3130200"/>
          </a:xfrm>
          <a:prstGeom prst="rect">
            <a:avLst/>
          </a:prstGeom>
          <a:noFill/>
          <a:ln w="0">
            <a:noFill/>
          </a:ln>
        </p:spPr>
        <p:txBody>
          <a:bodyPr lIns="52560" rIns="52560" tIns="26280" bIns="26280"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628800" y="5748840"/>
            <a:ext cx="3117240" cy="3130200"/>
          </a:xfrm>
          <a:prstGeom prst="rect">
            <a:avLst/>
          </a:prstGeom>
          <a:noFill/>
          <a:ln w="0">
            <a:noFill/>
          </a:ln>
        </p:spPr>
        <p:txBody>
          <a:bodyPr lIns="52560" rIns="52560" tIns="26280" bIns="26280"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92B3A3-8D5D-4B6D-B342-55792524034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55320" y="398520"/>
            <a:ext cx="6388200" cy="1657440"/>
          </a:xfrm>
          <a:prstGeom prst="rect">
            <a:avLst/>
          </a:prstGeom>
          <a:noFill/>
          <a:ln w="0">
            <a:noFill/>
          </a:ln>
        </p:spPr>
        <p:txBody>
          <a:bodyPr lIns="52560" rIns="52560" tIns="26280" bIns="2628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55320" y="2320920"/>
            <a:ext cx="3117240" cy="3130200"/>
          </a:xfrm>
          <a:prstGeom prst="rect">
            <a:avLst/>
          </a:prstGeom>
          <a:noFill/>
          <a:ln w="0">
            <a:noFill/>
          </a:ln>
        </p:spPr>
        <p:txBody>
          <a:bodyPr lIns="52560" rIns="52560" tIns="26280" bIns="26280"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628800" y="2320920"/>
            <a:ext cx="3117240" cy="3130200"/>
          </a:xfrm>
          <a:prstGeom prst="rect">
            <a:avLst/>
          </a:prstGeom>
          <a:noFill/>
          <a:ln w="0">
            <a:noFill/>
          </a:ln>
        </p:spPr>
        <p:txBody>
          <a:bodyPr lIns="52560" rIns="52560" tIns="26280" bIns="26280"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55320" y="5748840"/>
            <a:ext cx="6388200" cy="3130200"/>
          </a:xfrm>
          <a:prstGeom prst="rect">
            <a:avLst/>
          </a:prstGeom>
          <a:noFill/>
          <a:ln w="0">
            <a:noFill/>
          </a:ln>
        </p:spPr>
        <p:txBody>
          <a:bodyPr lIns="52560" rIns="52560" tIns="26280" bIns="26280"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A709165-C2C6-470D-B81A-9707B76FC64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55320" y="398520"/>
            <a:ext cx="6388200" cy="1657440"/>
          </a:xfrm>
          <a:prstGeom prst="rect">
            <a:avLst/>
          </a:prstGeom>
          <a:noFill/>
          <a:ln w="0">
            <a:noFill/>
          </a:ln>
        </p:spPr>
        <p:txBody>
          <a:bodyPr lIns="52560" rIns="52560" tIns="26280" bIns="2628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5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3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55320" y="2320920"/>
            <a:ext cx="6388200" cy="6562800"/>
          </a:xfrm>
          <a:prstGeom prst="rect">
            <a:avLst/>
          </a:prstGeom>
          <a:noFill/>
          <a:ln w="0">
            <a:noFill/>
          </a:ln>
        </p:spPr>
        <p:txBody>
          <a:bodyPr lIns="52560" rIns="52560" tIns="26280" bIns="26280" anchor="t">
            <a:normAutofit/>
          </a:bodyPr>
          <a:p>
            <a:pPr marL="276120" indent="-276120">
              <a:spcBef>
                <a:spcPts val="624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  <a:p>
            <a:pPr lvl="1" marL="600120" indent="-230400">
              <a:spcBef>
                <a:spcPts val="624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  <a:p>
            <a:pPr lvl="2" marL="925560" indent="-182520">
              <a:spcBef>
                <a:spcPts val="624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  <a:p>
            <a:pPr lvl="3" marL="1295280" indent="-182520">
              <a:spcBef>
                <a:spcPts val="624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  <a:p>
            <a:pPr lvl="4" marL="1666800" indent="-182520">
              <a:spcBef>
                <a:spcPts val="624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  <a:p>
            <a:pPr lvl="5" marL="1666800" indent="-182520">
              <a:spcBef>
                <a:spcPts val="624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  <a:p>
            <a:pPr lvl="6" marL="1666800" indent="-182520">
              <a:spcBef>
                <a:spcPts val="624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55320" y="9218160"/>
            <a:ext cx="1655640" cy="528840"/>
          </a:xfrm>
          <a:prstGeom prst="rect">
            <a:avLst/>
          </a:prstGeom>
          <a:noFill/>
          <a:ln w="0">
            <a:noFill/>
          </a:ln>
        </p:spPr>
        <p:txBody>
          <a:bodyPr lIns="52560" rIns="52560" tIns="26280" bIns="2628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9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9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425680" y="9218160"/>
            <a:ext cx="2247840" cy="528840"/>
          </a:xfrm>
          <a:prstGeom prst="rect">
            <a:avLst/>
          </a:prstGeom>
          <a:noFill/>
          <a:ln w="0">
            <a:noFill/>
          </a:ln>
        </p:spPr>
        <p:txBody>
          <a:bodyPr lIns="52560" rIns="52560" tIns="26280" bIns="2628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5087880" y="9218160"/>
            <a:ext cx="1656000" cy="528840"/>
          </a:xfrm>
          <a:prstGeom prst="rect">
            <a:avLst/>
          </a:prstGeom>
          <a:noFill/>
          <a:ln w="0">
            <a:noFill/>
          </a:ln>
        </p:spPr>
        <p:txBody>
          <a:bodyPr lIns="52560" rIns="52560" tIns="26280" bIns="2628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9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F247016-8877-46A0-9085-6DEB9C727360}" type="slidenum">
              <a:rPr b="0" lang="ja-JP" sz="9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wmf"/><Relationship Id="rId3" Type="http://schemas.openxmlformats.org/officeDocument/2006/relationships/image" Target="../media/image3.wmf"/><Relationship Id="rId4" Type="http://schemas.openxmlformats.org/officeDocument/2006/relationships/image" Target="../media/image4.wmf"/><Relationship Id="rId5" Type="http://schemas.openxmlformats.org/officeDocument/2006/relationships/image" Target="../media/image5.wmf"/><Relationship Id="rId6" Type="http://schemas.openxmlformats.org/officeDocument/2006/relationships/image" Target="../media/image5.wmf"/><Relationship Id="rId7" Type="http://schemas.openxmlformats.org/officeDocument/2006/relationships/image" Target="../media/image5.wmf"/><Relationship Id="rId8" Type="http://schemas.openxmlformats.org/officeDocument/2006/relationships/image" Target="../media/image5.wmf"/><Relationship Id="rId9" Type="http://schemas.openxmlformats.org/officeDocument/2006/relationships/image" Target="../media/image5.wmf"/><Relationship Id="rId10" Type="http://schemas.openxmlformats.org/officeDocument/2006/relationships/image" Target="../media/image6.wmf"/><Relationship Id="rId11" Type="http://schemas.openxmlformats.org/officeDocument/2006/relationships/image" Target="../media/image7.wmf"/><Relationship Id="rId12" Type="http://schemas.openxmlformats.org/officeDocument/2006/relationships/image" Target="../media/image3.wmf"/><Relationship Id="rId13" Type="http://schemas.openxmlformats.org/officeDocument/2006/relationships/image" Target="../media/image8.wmf"/><Relationship Id="rId14" Type="http://schemas.openxmlformats.org/officeDocument/2006/relationships/image" Target="../media/image5.wmf"/><Relationship Id="rId15" Type="http://schemas.openxmlformats.org/officeDocument/2006/relationships/image" Target="../media/image5.wmf"/><Relationship Id="rId16" Type="http://schemas.openxmlformats.org/officeDocument/2006/relationships/image" Target="../media/image5.wmf"/><Relationship Id="rId17" Type="http://schemas.openxmlformats.org/officeDocument/2006/relationships/image" Target="../media/image5.wmf"/><Relationship Id="rId18" Type="http://schemas.openxmlformats.org/officeDocument/2006/relationships/image" Target="../media/image5.wmf"/><Relationship Id="rId19" Type="http://schemas.openxmlformats.org/officeDocument/2006/relationships/image" Target="../media/image9.wmf"/><Relationship Id="rId20" Type="http://schemas.openxmlformats.org/officeDocument/2006/relationships/image" Target="../media/image6.wmf"/><Relationship Id="rId21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0.wmf"/><Relationship Id="rId2" Type="http://schemas.openxmlformats.org/officeDocument/2006/relationships/image" Target="../media/image11.wmf"/><Relationship Id="rId3" Type="http://schemas.openxmlformats.org/officeDocument/2006/relationships/image" Target="../media/image12.wmf"/><Relationship Id="rId4" Type="http://schemas.openxmlformats.org/officeDocument/2006/relationships/image" Target="../media/image13.wmf"/><Relationship Id="rId5" Type="http://schemas.openxmlformats.org/officeDocument/2006/relationships/image" Target="../media/image13.wmf"/><Relationship Id="rId6" Type="http://schemas.openxmlformats.org/officeDocument/2006/relationships/image" Target="../media/image14.wmf"/><Relationship Id="rId7" Type="http://schemas.openxmlformats.org/officeDocument/2006/relationships/image" Target="../media/image15.wmf"/><Relationship Id="rId8" Type="http://schemas.openxmlformats.org/officeDocument/2006/relationships/image" Target="../media/image16.wmf"/><Relationship Id="rId9" Type="http://schemas.openxmlformats.org/officeDocument/2006/relationships/image" Target="../media/image17.wmf"/><Relationship Id="rId10" Type="http://schemas.openxmlformats.org/officeDocument/2006/relationships/image" Target="../media/image14.wmf"/><Relationship Id="rId11" Type="http://schemas.openxmlformats.org/officeDocument/2006/relationships/image" Target="../media/image18.wmf"/><Relationship Id="rId12" Type="http://schemas.openxmlformats.org/officeDocument/2006/relationships/image" Target="../media/image16.wmf"/><Relationship Id="rId13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19.wmf"/><Relationship Id="rId2" Type="http://schemas.openxmlformats.org/officeDocument/2006/relationships/image" Target="../media/image20.wmf"/><Relationship Id="rId3" Type="http://schemas.openxmlformats.org/officeDocument/2006/relationships/image" Target="../media/image21.wmf"/><Relationship Id="rId4" Type="http://schemas.openxmlformats.org/officeDocument/2006/relationships/image" Target="../media/image21.wmf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3" descr=""/>
          <p:cNvPicPr/>
          <p:nvPr/>
        </p:nvPicPr>
        <p:blipFill>
          <a:blip r:embed="rId1"/>
          <a:stretch/>
        </p:blipFill>
        <p:spPr>
          <a:xfrm>
            <a:off x="797040" y="6670800"/>
            <a:ext cx="2305080" cy="1579320"/>
          </a:xfrm>
          <a:prstGeom prst="rect">
            <a:avLst/>
          </a:prstGeom>
          <a:ln w="0">
            <a:noFill/>
          </a:ln>
        </p:spPr>
      </p:pic>
      <p:sp>
        <p:nvSpPr>
          <p:cNvPr id="42" name="正方形/長方形 2"/>
          <p:cNvSpPr/>
          <p:nvPr/>
        </p:nvSpPr>
        <p:spPr>
          <a:xfrm>
            <a:off x="-1440" y="0"/>
            <a:ext cx="7100640" cy="417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2560" rIns="52560" tIns="26280" bIns="2628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Online Resource 4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Kaplan–Meier survival curves</a:t>
            </a:r>
            <a:r>
              <a:rPr b="0" lang="ja-JP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according to age (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) and extent of surgical resection (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)</a:t>
            </a:r>
            <a:r>
              <a:rPr b="0" lang="ja-JP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in</a:t>
            </a:r>
            <a:r>
              <a:rPr b="0" lang="ja-JP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WHO</a:t>
            </a:r>
            <a:r>
              <a:rPr b="0" lang="ja-JP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Grade</a:t>
            </a:r>
            <a:r>
              <a:rPr b="0" lang="ja-JP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IV</a:t>
            </a:r>
            <a:r>
              <a:rPr b="0" lang="ja-JP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cases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正方形/長方形 2"/>
          <p:cNvSpPr/>
          <p:nvPr/>
        </p:nvSpPr>
        <p:spPr>
          <a:xfrm>
            <a:off x="316080" y="768240"/>
            <a:ext cx="6467400" cy="23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2560" rIns="52560" tIns="26280" bIns="2628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r>
              <a:rPr b="0" lang="en-US" sz="1200" spc="-1" strike="noStrike">
                <a:solidFill>
                  <a:srgbClr val="ffffff"/>
                </a:solidFill>
                <a:latin typeface="Arial"/>
                <a:ea typeface="Arial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Age                                                                 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44" name=""/>
          <p:cNvGraphicFramePr/>
          <p:nvPr/>
        </p:nvGraphicFramePr>
        <p:xfrm>
          <a:off x="393840" y="2728800"/>
          <a:ext cx="2808000" cy="731880"/>
        </p:xfrm>
        <a:graphic>
          <a:graphicData uri="http://schemas.openxmlformats.org/drawingml/2006/table">
            <a:tbl>
              <a:tblPr/>
              <a:tblGrid>
                <a:gridCol w="517320"/>
                <a:gridCol w="381240"/>
                <a:gridCol w="382320"/>
                <a:gridCol w="381240"/>
                <a:gridCol w="382320"/>
                <a:gridCol w="381240"/>
                <a:gridCol w="382320"/>
              </a:tblGrid>
              <a:tr h="183240">
                <a:tc gridSpan="7"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umber at risk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83240"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70-74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0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8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83240"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75-79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4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3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83240"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80-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8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</a:tbl>
          </a:graphicData>
        </a:graphic>
      </p:graphicFrame>
      <p:grpSp>
        <p:nvGrpSpPr>
          <p:cNvPr id="45" name="図形グループ 4"/>
          <p:cNvGrpSpPr/>
          <p:nvPr/>
        </p:nvGrpSpPr>
        <p:grpSpPr>
          <a:xfrm>
            <a:off x="741240" y="939960"/>
            <a:ext cx="2306880" cy="1795320"/>
            <a:chOff x="741240" y="939960"/>
            <a:chExt cx="2306880" cy="1795320"/>
          </a:xfrm>
        </p:grpSpPr>
        <p:grpSp>
          <p:nvGrpSpPr>
            <p:cNvPr id="46" name="図形グループ 2"/>
            <p:cNvGrpSpPr/>
            <p:nvPr/>
          </p:nvGrpSpPr>
          <p:grpSpPr>
            <a:xfrm>
              <a:off x="741240" y="1156320"/>
              <a:ext cx="2306880" cy="1578960"/>
              <a:chOff x="741240" y="1156320"/>
              <a:chExt cx="2306880" cy="1578960"/>
            </a:xfrm>
          </p:grpSpPr>
          <p:pic>
            <p:nvPicPr>
              <p:cNvPr id="47" name="Picture 3" descr=""/>
              <p:cNvPicPr/>
              <p:nvPr/>
            </p:nvPicPr>
            <p:blipFill>
              <a:blip r:embed="rId2"/>
              <a:stretch/>
            </p:blipFill>
            <p:spPr>
              <a:xfrm>
                <a:off x="741240" y="1156320"/>
                <a:ext cx="2306880" cy="157896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48" name="Picture 2" descr=""/>
              <p:cNvPicPr/>
              <p:nvPr/>
            </p:nvPicPr>
            <p:blipFill>
              <a:blip r:embed="rId3"/>
              <a:stretch/>
            </p:blipFill>
            <p:spPr>
              <a:xfrm>
                <a:off x="2495880" y="1196280"/>
                <a:ext cx="465840" cy="33264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49" name="正方形/長方形 2"/>
              <p:cNvSpPr/>
              <p:nvPr/>
            </p:nvSpPr>
            <p:spPr>
              <a:xfrm>
                <a:off x="2129040" y="1523520"/>
                <a:ext cx="834480" cy="2354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52560" rIns="52560" tIns="26280" bIns="2628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p = 0.1129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50" name="正方形/長方形 2"/>
            <p:cNvSpPr/>
            <p:nvPr/>
          </p:nvSpPr>
          <p:spPr>
            <a:xfrm>
              <a:off x="1516320" y="939960"/>
              <a:ext cx="718560" cy="2354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52560" rIns="52560" tIns="26280" bIns="2628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 u="sng">
                  <a:solidFill>
                    <a:srgbClr val="000000"/>
                  </a:solidFill>
                  <a:uFillTx/>
                  <a:latin typeface="Arial"/>
                  <a:ea typeface="Arial"/>
                </a:rPr>
                <a:t>Grade IV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51" name="正方形/長方形 17"/>
          <p:cNvSpPr/>
          <p:nvPr/>
        </p:nvSpPr>
        <p:spPr>
          <a:xfrm>
            <a:off x="316080" y="3468600"/>
            <a:ext cx="6783120" cy="23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2560" rIns="52560" tIns="26280" bIns="2628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 Extent of surgical resection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52" name=""/>
          <p:cNvGraphicFramePr/>
          <p:nvPr/>
        </p:nvGraphicFramePr>
        <p:xfrm>
          <a:off x="380880" y="5508720"/>
          <a:ext cx="2808360" cy="914400"/>
        </p:xfrm>
        <a:graphic>
          <a:graphicData uri="http://schemas.openxmlformats.org/drawingml/2006/table">
            <a:tbl>
              <a:tblPr/>
              <a:tblGrid>
                <a:gridCol w="517680"/>
                <a:gridCol w="380880"/>
                <a:gridCol w="382680"/>
                <a:gridCol w="380880"/>
                <a:gridCol w="382680"/>
                <a:gridCol w="380880"/>
                <a:gridCol w="382680"/>
              </a:tblGrid>
              <a:tr h="185400">
                <a:tc gridSpan="7">
                  <a:txBody>
                    <a:bodyPr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umber at risk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85400">
                <a:tc>
                  <a:txBody>
                    <a:bodyPr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TR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2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7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85400">
                <a:tc>
                  <a:txBody>
                    <a:bodyPr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STR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7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85400">
                <a:tc>
                  <a:txBody>
                    <a:bodyPr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R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9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8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85400">
                <a:tc>
                  <a:txBody>
                    <a:bodyPr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Biopsy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4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7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</a:tbl>
          </a:graphicData>
        </a:graphic>
      </p:graphicFrame>
      <p:grpSp>
        <p:nvGrpSpPr>
          <p:cNvPr id="53" name="図形グループ 6"/>
          <p:cNvGrpSpPr/>
          <p:nvPr/>
        </p:nvGrpSpPr>
        <p:grpSpPr>
          <a:xfrm>
            <a:off x="766800" y="3708360"/>
            <a:ext cx="2306520" cy="1797120"/>
            <a:chOff x="766800" y="3708360"/>
            <a:chExt cx="2306520" cy="1797120"/>
          </a:xfrm>
        </p:grpSpPr>
        <p:grpSp>
          <p:nvGrpSpPr>
            <p:cNvPr id="54" name="図形グループ 5"/>
            <p:cNvGrpSpPr/>
            <p:nvPr/>
          </p:nvGrpSpPr>
          <p:grpSpPr>
            <a:xfrm>
              <a:off x="766800" y="3927240"/>
              <a:ext cx="2306520" cy="1578240"/>
              <a:chOff x="766800" y="3927240"/>
              <a:chExt cx="2306520" cy="1578240"/>
            </a:xfrm>
          </p:grpSpPr>
          <p:pic>
            <p:nvPicPr>
              <p:cNvPr id="55" name="Picture 3" descr=""/>
              <p:cNvPicPr/>
              <p:nvPr/>
            </p:nvPicPr>
            <p:blipFill>
              <a:blip r:embed="rId4"/>
              <a:stretch/>
            </p:blipFill>
            <p:spPr>
              <a:xfrm>
                <a:off x="766800" y="3927240"/>
                <a:ext cx="2306520" cy="1578240"/>
              </a:xfrm>
              <a:prstGeom prst="rect">
                <a:avLst/>
              </a:prstGeom>
              <a:ln w="0">
                <a:noFill/>
              </a:ln>
            </p:spPr>
          </p:pic>
          <p:grpSp>
            <p:nvGrpSpPr>
              <p:cNvPr id="56" name="図形グループ 2"/>
              <p:cNvGrpSpPr/>
              <p:nvPr/>
            </p:nvGrpSpPr>
            <p:grpSpPr>
              <a:xfrm>
                <a:off x="2481840" y="3968280"/>
                <a:ext cx="514800" cy="439920"/>
                <a:chOff x="2481840" y="3968280"/>
                <a:chExt cx="514800" cy="439920"/>
              </a:xfrm>
            </p:grpSpPr>
            <p:pic>
              <p:nvPicPr>
                <p:cNvPr id="57" name="Picture 2" descr=""/>
                <p:cNvPicPr/>
                <p:nvPr/>
              </p:nvPicPr>
              <p:blipFill>
                <a:blip r:embed="rId5"/>
                <a:stretch/>
              </p:blipFill>
              <p:spPr>
                <a:xfrm>
                  <a:off x="2481840" y="3968280"/>
                  <a:ext cx="514800" cy="43992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58" name="Picture 2" descr=""/>
                <p:cNvPicPr/>
                <p:nvPr/>
              </p:nvPicPr>
              <p:blipFill>
                <a:blip r:embed="rId6"/>
                <a:srcRect l="0" t="25773" r="0" b="5007"/>
                <a:stretch/>
              </p:blipFill>
              <p:spPr>
                <a:xfrm>
                  <a:off x="2481840" y="3993120"/>
                  <a:ext cx="514800" cy="30456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59" name="Picture 2" descr=""/>
                <p:cNvPicPr/>
                <p:nvPr/>
              </p:nvPicPr>
              <p:blipFill>
                <a:blip r:embed="rId7"/>
                <a:srcRect l="0" t="2651" r="0" b="70434"/>
                <a:stretch/>
              </p:blipFill>
              <p:spPr>
                <a:xfrm>
                  <a:off x="2481840" y="4259880"/>
                  <a:ext cx="514800" cy="11844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60" name="Picture 2" descr=""/>
                <p:cNvPicPr/>
                <p:nvPr/>
              </p:nvPicPr>
              <p:blipFill>
                <a:blip r:embed="rId8"/>
                <a:srcRect l="0" t="65906" r="0" b="12003"/>
                <a:stretch/>
              </p:blipFill>
              <p:spPr>
                <a:xfrm>
                  <a:off x="2481840" y="4077360"/>
                  <a:ext cx="514800" cy="9720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61" name="Picture 2" descr=""/>
                <p:cNvPicPr/>
                <p:nvPr/>
              </p:nvPicPr>
              <p:blipFill>
                <a:blip r:embed="rId9"/>
                <a:srcRect l="0" t="45839" r="0" b="33984"/>
                <a:stretch/>
              </p:blipFill>
              <p:spPr>
                <a:xfrm>
                  <a:off x="2481840" y="4175280"/>
                  <a:ext cx="514800" cy="88920"/>
                </a:xfrm>
                <a:prstGeom prst="rect">
                  <a:avLst/>
                </a:prstGeom>
                <a:ln w="0">
                  <a:noFill/>
                </a:ln>
              </p:spPr>
            </p:pic>
          </p:grpSp>
          <p:sp>
            <p:nvSpPr>
              <p:cNvPr id="62" name="正方形/長方形 2"/>
              <p:cNvSpPr/>
              <p:nvPr/>
            </p:nvSpPr>
            <p:spPr>
              <a:xfrm>
                <a:off x="2139840" y="4438080"/>
                <a:ext cx="834480" cy="2354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52560" rIns="52560" tIns="26280" bIns="2628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p = 0.7448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63" name="正方形/長方形 2"/>
            <p:cNvSpPr/>
            <p:nvPr/>
          </p:nvSpPr>
          <p:spPr>
            <a:xfrm>
              <a:off x="1503000" y="3708360"/>
              <a:ext cx="7934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 u="sng">
                  <a:solidFill>
                    <a:srgbClr val="000000"/>
                  </a:solidFill>
                  <a:uFillTx/>
                  <a:latin typeface="Arial"/>
                  <a:ea typeface="Arial"/>
                </a:rPr>
                <a:t>Grade IV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aphicFrame>
        <p:nvGraphicFramePr>
          <p:cNvPr id="64" name=""/>
          <p:cNvGraphicFramePr/>
          <p:nvPr/>
        </p:nvGraphicFramePr>
        <p:xfrm>
          <a:off x="366840" y="8240760"/>
          <a:ext cx="2741400" cy="549360"/>
        </p:xfrm>
        <a:graphic>
          <a:graphicData uri="http://schemas.openxmlformats.org/drawingml/2006/table">
            <a:tbl>
              <a:tblPr/>
              <a:tblGrid>
                <a:gridCol w="647640"/>
                <a:gridCol w="322200"/>
                <a:gridCol w="360360"/>
                <a:gridCol w="360360"/>
                <a:gridCol w="431640"/>
                <a:gridCol w="360360"/>
                <a:gridCol w="258840"/>
              </a:tblGrid>
              <a:tr h="183240">
                <a:tc gridSpan="7"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umber at risk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83240"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TR+STR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8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1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83240"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R+Biopsy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74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4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65" name="正方形/長方形 8"/>
          <p:cNvSpPr/>
          <p:nvPr/>
        </p:nvSpPr>
        <p:spPr>
          <a:xfrm>
            <a:off x="1501920" y="6423120"/>
            <a:ext cx="793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 u="sng">
                <a:solidFill>
                  <a:srgbClr val="000000"/>
                </a:solidFill>
                <a:uFillTx/>
                <a:latin typeface="Arial"/>
                <a:ea typeface="Arial"/>
              </a:rPr>
              <a:t>Grade IV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正方形/長方形 2"/>
          <p:cNvSpPr/>
          <p:nvPr/>
        </p:nvSpPr>
        <p:spPr>
          <a:xfrm>
            <a:off x="2198160" y="7026120"/>
            <a:ext cx="834480" cy="23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52560" rIns="52560" tIns="26280" bIns="2628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p = 0.6386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7" name="Picture 4" descr=""/>
          <p:cNvPicPr/>
          <p:nvPr/>
        </p:nvPicPr>
        <p:blipFill>
          <a:blip r:embed="rId10"/>
          <a:stretch/>
        </p:blipFill>
        <p:spPr>
          <a:xfrm>
            <a:off x="2293920" y="6719760"/>
            <a:ext cx="738360" cy="273240"/>
          </a:xfrm>
          <a:prstGeom prst="rect">
            <a:avLst/>
          </a:prstGeom>
          <a:ln w="0">
            <a:noFill/>
          </a:ln>
        </p:spPr>
      </p:pic>
      <p:graphicFrame>
        <p:nvGraphicFramePr>
          <p:cNvPr id="68" name=""/>
          <p:cNvGraphicFramePr/>
          <p:nvPr/>
        </p:nvGraphicFramePr>
        <p:xfrm>
          <a:off x="3693960" y="2728800"/>
          <a:ext cx="2808360" cy="731880"/>
        </p:xfrm>
        <a:graphic>
          <a:graphicData uri="http://schemas.openxmlformats.org/drawingml/2006/table">
            <a:tbl>
              <a:tblPr/>
              <a:tblGrid>
                <a:gridCol w="517680"/>
                <a:gridCol w="380880"/>
                <a:gridCol w="382680"/>
                <a:gridCol w="380880"/>
                <a:gridCol w="382680"/>
                <a:gridCol w="380880"/>
                <a:gridCol w="382680"/>
              </a:tblGrid>
              <a:tr h="183240">
                <a:tc gridSpan="7"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umber at risk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83240"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70-74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0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7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0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83240"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75-79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4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0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83240"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80-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8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8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</a:tbl>
          </a:graphicData>
        </a:graphic>
      </p:graphicFrame>
      <p:grpSp>
        <p:nvGrpSpPr>
          <p:cNvPr id="69" name="図形グループ 8"/>
          <p:cNvGrpSpPr/>
          <p:nvPr/>
        </p:nvGrpSpPr>
        <p:grpSpPr>
          <a:xfrm>
            <a:off x="4041720" y="939960"/>
            <a:ext cx="2306520" cy="1795320"/>
            <a:chOff x="4041720" y="939960"/>
            <a:chExt cx="2306520" cy="1795320"/>
          </a:xfrm>
        </p:grpSpPr>
        <p:grpSp>
          <p:nvGrpSpPr>
            <p:cNvPr id="70" name="図形グループ 7"/>
            <p:cNvGrpSpPr/>
            <p:nvPr/>
          </p:nvGrpSpPr>
          <p:grpSpPr>
            <a:xfrm>
              <a:off x="4041720" y="1155960"/>
              <a:ext cx="2306520" cy="1579320"/>
              <a:chOff x="4041720" y="1155960"/>
              <a:chExt cx="2306520" cy="1579320"/>
            </a:xfrm>
          </p:grpSpPr>
          <p:pic>
            <p:nvPicPr>
              <p:cNvPr id="71" name="Picture 3" descr=""/>
              <p:cNvPicPr/>
              <p:nvPr/>
            </p:nvPicPr>
            <p:blipFill>
              <a:blip r:embed="rId11"/>
              <a:stretch/>
            </p:blipFill>
            <p:spPr>
              <a:xfrm>
                <a:off x="4041720" y="1155960"/>
                <a:ext cx="2306520" cy="157932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72" name="Picture 2" descr=""/>
              <p:cNvPicPr/>
              <p:nvPr/>
            </p:nvPicPr>
            <p:blipFill>
              <a:blip r:embed="rId12"/>
              <a:stretch/>
            </p:blipFill>
            <p:spPr>
              <a:xfrm>
                <a:off x="5795640" y="1196280"/>
                <a:ext cx="465840" cy="33264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73" name="正方形/長方形 2"/>
              <p:cNvSpPr/>
              <p:nvPr/>
            </p:nvSpPr>
            <p:spPr>
              <a:xfrm>
                <a:off x="5361840" y="1523520"/>
                <a:ext cx="893880" cy="2354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52560" rIns="52560" tIns="26280" bIns="2628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p = 0.0154*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74" name="正方形/長方形 2"/>
            <p:cNvSpPr/>
            <p:nvPr/>
          </p:nvSpPr>
          <p:spPr>
            <a:xfrm>
              <a:off x="4816080" y="939960"/>
              <a:ext cx="718560" cy="2354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52560" rIns="52560" tIns="26280" bIns="2628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 u="sng">
                  <a:solidFill>
                    <a:srgbClr val="000000"/>
                  </a:solidFill>
                  <a:uFillTx/>
                  <a:latin typeface="Arial"/>
                  <a:ea typeface="Arial"/>
                </a:rPr>
                <a:t>Grade IV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aphicFrame>
        <p:nvGraphicFramePr>
          <p:cNvPr id="75" name=""/>
          <p:cNvGraphicFramePr/>
          <p:nvPr/>
        </p:nvGraphicFramePr>
        <p:xfrm>
          <a:off x="3681360" y="5508720"/>
          <a:ext cx="2808360" cy="914400"/>
        </p:xfrm>
        <a:graphic>
          <a:graphicData uri="http://schemas.openxmlformats.org/drawingml/2006/table">
            <a:tbl>
              <a:tblPr/>
              <a:tblGrid>
                <a:gridCol w="517680"/>
                <a:gridCol w="380880"/>
                <a:gridCol w="382680"/>
                <a:gridCol w="380880"/>
                <a:gridCol w="382680"/>
                <a:gridCol w="380880"/>
                <a:gridCol w="382680"/>
              </a:tblGrid>
              <a:tr h="185400">
                <a:tc gridSpan="7">
                  <a:txBody>
                    <a:bodyPr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umber at risk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85400">
                <a:tc>
                  <a:txBody>
                    <a:bodyPr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TR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2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5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85400">
                <a:tc>
                  <a:txBody>
                    <a:bodyPr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STR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7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9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85400">
                <a:tc>
                  <a:txBody>
                    <a:bodyPr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R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9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3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8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85400">
                <a:tc>
                  <a:txBody>
                    <a:bodyPr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Biopsy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4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9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</a:tbl>
          </a:graphicData>
        </a:graphic>
      </p:graphicFrame>
      <p:grpSp>
        <p:nvGrpSpPr>
          <p:cNvPr id="76" name="図形グループ 10"/>
          <p:cNvGrpSpPr/>
          <p:nvPr/>
        </p:nvGrpSpPr>
        <p:grpSpPr>
          <a:xfrm>
            <a:off x="4065480" y="3708360"/>
            <a:ext cx="2306880" cy="1784520"/>
            <a:chOff x="4065480" y="3708360"/>
            <a:chExt cx="2306880" cy="1784520"/>
          </a:xfrm>
        </p:grpSpPr>
        <p:grpSp>
          <p:nvGrpSpPr>
            <p:cNvPr id="77" name="図形グループ 9"/>
            <p:cNvGrpSpPr/>
            <p:nvPr/>
          </p:nvGrpSpPr>
          <p:grpSpPr>
            <a:xfrm>
              <a:off x="4065480" y="3924360"/>
              <a:ext cx="2306880" cy="1568520"/>
              <a:chOff x="4065480" y="3924360"/>
              <a:chExt cx="2306880" cy="1568520"/>
            </a:xfrm>
          </p:grpSpPr>
          <p:pic>
            <p:nvPicPr>
              <p:cNvPr id="78" name="Picture 3" descr=""/>
              <p:cNvPicPr/>
              <p:nvPr/>
            </p:nvPicPr>
            <p:blipFill>
              <a:blip r:embed="rId13"/>
              <a:stretch/>
            </p:blipFill>
            <p:spPr>
              <a:xfrm>
                <a:off x="4065480" y="3924360"/>
                <a:ext cx="2306880" cy="1568520"/>
              </a:xfrm>
              <a:prstGeom prst="rect">
                <a:avLst/>
              </a:prstGeom>
              <a:ln w="0">
                <a:noFill/>
              </a:ln>
            </p:spPr>
          </p:pic>
          <p:grpSp>
            <p:nvGrpSpPr>
              <p:cNvPr id="79" name="図形グループ 2"/>
              <p:cNvGrpSpPr/>
              <p:nvPr/>
            </p:nvGrpSpPr>
            <p:grpSpPr>
              <a:xfrm>
                <a:off x="5781960" y="3968280"/>
                <a:ext cx="514800" cy="439920"/>
                <a:chOff x="5781960" y="3968280"/>
                <a:chExt cx="514800" cy="439920"/>
              </a:xfrm>
            </p:grpSpPr>
            <p:pic>
              <p:nvPicPr>
                <p:cNvPr id="80" name="Picture 2" descr=""/>
                <p:cNvPicPr/>
                <p:nvPr/>
              </p:nvPicPr>
              <p:blipFill>
                <a:blip r:embed="rId14"/>
                <a:stretch/>
              </p:blipFill>
              <p:spPr>
                <a:xfrm>
                  <a:off x="5781960" y="3968280"/>
                  <a:ext cx="514800" cy="43992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81" name="Picture 2" descr=""/>
                <p:cNvPicPr/>
                <p:nvPr/>
              </p:nvPicPr>
              <p:blipFill>
                <a:blip r:embed="rId15"/>
                <a:srcRect l="0" t="25773" r="0" b="5007"/>
                <a:stretch/>
              </p:blipFill>
              <p:spPr>
                <a:xfrm>
                  <a:off x="5781960" y="3993120"/>
                  <a:ext cx="514800" cy="30456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82" name="Picture 2" descr=""/>
                <p:cNvPicPr/>
                <p:nvPr/>
              </p:nvPicPr>
              <p:blipFill>
                <a:blip r:embed="rId16"/>
                <a:srcRect l="0" t="2651" r="0" b="70434"/>
                <a:stretch/>
              </p:blipFill>
              <p:spPr>
                <a:xfrm>
                  <a:off x="5781960" y="4259880"/>
                  <a:ext cx="514800" cy="11844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83" name="Picture 2" descr=""/>
                <p:cNvPicPr/>
                <p:nvPr/>
              </p:nvPicPr>
              <p:blipFill>
                <a:blip r:embed="rId17"/>
                <a:srcRect l="0" t="65906" r="0" b="12003"/>
                <a:stretch/>
              </p:blipFill>
              <p:spPr>
                <a:xfrm>
                  <a:off x="5781960" y="4077360"/>
                  <a:ext cx="514800" cy="9720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84" name="Picture 2" descr=""/>
                <p:cNvPicPr/>
                <p:nvPr/>
              </p:nvPicPr>
              <p:blipFill>
                <a:blip r:embed="rId18"/>
                <a:srcRect l="0" t="45839" r="0" b="33984"/>
                <a:stretch/>
              </p:blipFill>
              <p:spPr>
                <a:xfrm>
                  <a:off x="5781960" y="4175280"/>
                  <a:ext cx="514800" cy="88920"/>
                </a:xfrm>
                <a:prstGeom prst="rect">
                  <a:avLst/>
                </a:prstGeom>
                <a:ln w="0">
                  <a:noFill/>
                </a:ln>
              </p:spPr>
            </p:pic>
          </p:grpSp>
          <p:sp>
            <p:nvSpPr>
              <p:cNvPr id="85" name="正方形/長方形 2"/>
              <p:cNvSpPr/>
              <p:nvPr/>
            </p:nvSpPr>
            <p:spPr>
              <a:xfrm>
                <a:off x="5439600" y="4438440"/>
                <a:ext cx="834480" cy="2354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52560" rIns="52560" tIns="26280" bIns="2628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p = 0.1046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86" name="正方形/長方形 2"/>
            <p:cNvSpPr/>
            <p:nvPr/>
          </p:nvSpPr>
          <p:spPr>
            <a:xfrm>
              <a:off x="4802760" y="3708360"/>
              <a:ext cx="7934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 u="sng">
                  <a:solidFill>
                    <a:srgbClr val="000000"/>
                  </a:solidFill>
                  <a:uFillTx/>
                  <a:latin typeface="Arial"/>
                  <a:ea typeface="Arial"/>
                </a:rPr>
                <a:t>Grade IV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aphicFrame>
        <p:nvGraphicFramePr>
          <p:cNvPr id="87" name=""/>
          <p:cNvGraphicFramePr/>
          <p:nvPr/>
        </p:nvGraphicFramePr>
        <p:xfrm>
          <a:off x="3666960" y="8240760"/>
          <a:ext cx="2741760" cy="549360"/>
        </p:xfrm>
        <a:graphic>
          <a:graphicData uri="http://schemas.openxmlformats.org/drawingml/2006/table">
            <a:tbl>
              <a:tblPr/>
              <a:tblGrid>
                <a:gridCol w="648000"/>
                <a:gridCol w="322200"/>
                <a:gridCol w="360360"/>
                <a:gridCol w="360360"/>
                <a:gridCol w="431640"/>
                <a:gridCol w="360360"/>
                <a:gridCol w="258840"/>
              </a:tblGrid>
              <a:tr h="183240">
                <a:tc gridSpan="7"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umber at risk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83240"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TR+STR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8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3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7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83240"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R+Biopsy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74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1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7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</a:tbl>
          </a:graphicData>
        </a:graphic>
      </p:graphicFrame>
      <p:grpSp>
        <p:nvGrpSpPr>
          <p:cNvPr id="88" name="図形グループ 11"/>
          <p:cNvGrpSpPr/>
          <p:nvPr/>
        </p:nvGrpSpPr>
        <p:grpSpPr>
          <a:xfrm>
            <a:off x="4098960" y="6423120"/>
            <a:ext cx="2306520" cy="1830240"/>
            <a:chOff x="4098960" y="6423120"/>
            <a:chExt cx="2306520" cy="1830240"/>
          </a:xfrm>
        </p:grpSpPr>
        <p:sp>
          <p:nvSpPr>
            <p:cNvPr id="89" name="正方形/長方形 8"/>
            <p:cNvSpPr/>
            <p:nvPr/>
          </p:nvSpPr>
          <p:spPr>
            <a:xfrm>
              <a:off x="4801680" y="6423120"/>
              <a:ext cx="7934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 u="sng">
                  <a:solidFill>
                    <a:srgbClr val="000000"/>
                  </a:solidFill>
                  <a:uFillTx/>
                  <a:latin typeface="Arial"/>
                  <a:ea typeface="Arial"/>
                </a:rPr>
                <a:t>Grade IV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90" name="図形グループ 1"/>
            <p:cNvGrpSpPr/>
            <p:nvPr/>
          </p:nvGrpSpPr>
          <p:grpSpPr>
            <a:xfrm>
              <a:off x="4098960" y="6675480"/>
              <a:ext cx="2306520" cy="1577880"/>
              <a:chOff x="4098960" y="6675480"/>
              <a:chExt cx="2306520" cy="1577880"/>
            </a:xfrm>
          </p:grpSpPr>
          <p:pic>
            <p:nvPicPr>
              <p:cNvPr id="91" name="Picture 3" descr=""/>
              <p:cNvPicPr/>
              <p:nvPr/>
            </p:nvPicPr>
            <p:blipFill>
              <a:blip r:embed="rId19"/>
              <a:stretch/>
            </p:blipFill>
            <p:spPr>
              <a:xfrm>
                <a:off x="4098960" y="6675480"/>
                <a:ext cx="2306520" cy="157788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92" name="正方形/長方形 2"/>
              <p:cNvSpPr/>
              <p:nvPr/>
            </p:nvSpPr>
            <p:spPr>
              <a:xfrm>
                <a:off x="5436720" y="7027200"/>
                <a:ext cx="893880" cy="2354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52560" rIns="52560" tIns="26280" bIns="2628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p = 0.0310*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pic>
            <p:nvPicPr>
              <p:cNvPr id="93" name="Picture 4" descr=""/>
              <p:cNvPicPr/>
              <p:nvPr/>
            </p:nvPicPr>
            <p:blipFill>
              <a:blip r:embed="rId20"/>
              <a:stretch/>
            </p:blipFill>
            <p:spPr>
              <a:xfrm>
                <a:off x="5594400" y="6720480"/>
                <a:ext cx="737280" cy="272880"/>
              </a:xfrm>
              <a:prstGeom prst="rect">
                <a:avLst/>
              </a:prstGeom>
              <a:ln w="0">
                <a:noFill/>
              </a:ln>
            </p:spPr>
          </p:pic>
        </p:grp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4" name="Picture 1" descr=""/>
          <p:cNvPicPr/>
          <p:nvPr/>
        </p:nvPicPr>
        <p:blipFill>
          <a:blip r:embed="rId1"/>
          <a:stretch/>
        </p:blipFill>
        <p:spPr>
          <a:xfrm>
            <a:off x="749160" y="6581880"/>
            <a:ext cx="2306880" cy="1579320"/>
          </a:xfrm>
          <a:prstGeom prst="rect">
            <a:avLst/>
          </a:prstGeom>
          <a:ln w="0">
            <a:noFill/>
          </a:ln>
        </p:spPr>
      </p:pic>
      <p:pic>
        <p:nvPicPr>
          <p:cNvPr id="95" name="Picture 3" descr=""/>
          <p:cNvPicPr/>
          <p:nvPr/>
        </p:nvPicPr>
        <p:blipFill>
          <a:blip r:embed="rId2"/>
          <a:stretch/>
        </p:blipFill>
        <p:spPr>
          <a:xfrm>
            <a:off x="741240" y="1155600"/>
            <a:ext cx="2306880" cy="1568520"/>
          </a:xfrm>
          <a:prstGeom prst="rect">
            <a:avLst/>
          </a:prstGeom>
          <a:ln w="0">
            <a:noFill/>
          </a:ln>
        </p:spPr>
      </p:pic>
      <p:graphicFrame>
        <p:nvGraphicFramePr>
          <p:cNvPr id="96" name=""/>
          <p:cNvGraphicFramePr/>
          <p:nvPr/>
        </p:nvGraphicFramePr>
        <p:xfrm>
          <a:off x="3586320" y="2766960"/>
          <a:ext cx="3058920" cy="549360"/>
        </p:xfrm>
        <a:graphic>
          <a:graphicData uri="http://schemas.openxmlformats.org/drawingml/2006/table">
            <a:tbl>
              <a:tblPr/>
              <a:tblGrid>
                <a:gridCol w="766440"/>
                <a:gridCol w="382680"/>
                <a:gridCol w="382680"/>
                <a:gridCol w="380880"/>
                <a:gridCol w="382680"/>
                <a:gridCol w="380880"/>
                <a:gridCol w="382680"/>
              </a:tblGrid>
              <a:tr h="183240">
                <a:tc gridSpan="7"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umber at risk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83240"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methylated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1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4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8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83240"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unmethylated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61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0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6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</a:tbl>
          </a:graphicData>
        </a:graphic>
      </p:graphicFrame>
      <p:pic>
        <p:nvPicPr>
          <p:cNvPr id="97" name="Picture 3" descr=""/>
          <p:cNvPicPr/>
          <p:nvPr/>
        </p:nvPicPr>
        <p:blipFill>
          <a:blip r:embed="rId3"/>
          <a:stretch/>
        </p:blipFill>
        <p:spPr>
          <a:xfrm>
            <a:off x="4194000" y="1173240"/>
            <a:ext cx="2306880" cy="1577880"/>
          </a:xfrm>
          <a:prstGeom prst="rect">
            <a:avLst/>
          </a:prstGeom>
          <a:ln w="0">
            <a:noFill/>
          </a:ln>
        </p:spPr>
      </p:pic>
      <p:pic>
        <p:nvPicPr>
          <p:cNvPr id="98" name="Picture 2" descr=""/>
          <p:cNvPicPr/>
          <p:nvPr/>
        </p:nvPicPr>
        <p:blipFill>
          <a:blip r:embed="rId4"/>
          <a:stretch/>
        </p:blipFill>
        <p:spPr>
          <a:xfrm>
            <a:off x="5587920" y="1219320"/>
            <a:ext cx="838440" cy="277560"/>
          </a:xfrm>
          <a:prstGeom prst="rect">
            <a:avLst/>
          </a:prstGeom>
          <a:ln w="0">
            <a:noFill/>
          </a:ln>
        </p:spPr>
      </p:pic>
      <p:sp>
        <p:nvSpPr>
          <p:cNvPr id="99" name="正方形/長方形 2"/>
          <p:cNvSpPr/>
          <p:nvPr/>
        </p:nvSpPr>
        <p:spPr>
          <a:xfrm>
            <a:off x="5560560" y="1508040"/>
            <a:ext cx="834480" cy="23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52560" rIns="52560" tIns="26280" bIns="2628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p = 0.324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0" name="正方形/長方形 18"/>
          <p:cNvSpPr/>
          <p:nvPr/>
        </p:nvSpPr>
        <p:spPr>
          <a:xfrm>
            <a:off x="4919760" y="939960"/>
            <a:ext cx="793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 u="sng">
                <a:solidFill>
                  <a:srgbClr val="000000"/>
                </a:solidFill>
                <a:uFillTx/>
                <a:latin typeface="Arial"/>
                <a:ea typeface="Arial"/>
              </a:rPr>
              <a:t>Grade IV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1" name="正方形/長方形 2"/>
          <p:cNvSpPr/>
          <p:nvPr/>
        </p:nvSpPr>
        <p:spPr>
          <a:xfrm>
            <a:off x="-1440" y="0"/>
            <a:ext cx="7100640" cy="600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2560" rIns="52560" tIns="26280" bIns="2628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Online Resource 5</a:t>
            </a:r>
            <a:r>
              <a:rPr b="1" lang="ja-JP" sz="12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Kaplan–Meier survival curves</a:t>
            </a:r>
            <a:r>
              <a:rPr b="0" lang="ja-JP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according to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MGMT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 promotor methylation status (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) and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TERT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 promoter mutation </a:t>
            </a:r>
            <a:r>
              <a:rPr b="0" lang="ja-JP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s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tatus (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)</a:t>
            </a:r>
            <a:r>
              <a:rPr b="0" lang="ja-JP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in</a:t>
            </a:r>
            <a:r>
              <a:rPr b="0" lang="ja-JP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WHO</a:t>
            </a:r>
            <a:r>
              <a:rPr b="0" lang="ja-JP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Grade</a:t>
            </a:r>
            <a:r>
              <a:rPr b="0" lang="ja-JP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IV</a:t>
            </a:r>
            <a:r>
              <a:rPr b="0" lang="ja-JP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cases</a:t>
            </a:r>
            <a:r>
              <a:rPr b="0" lang="ja-JP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and</a:t>
            </a:r>
            <a:r>
              <a:rPr b="0" lang="ja-JP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IDH1/2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mutation status</a:t>
            </a:r>
            <a:r>
              <a:rPr b="0" lang="ja-JP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in</a:t>
            </a:r>
            <a:r>
              <a:rPr b="0" lang="ja-JP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WHO</a:t>
            </a:r>
            <a:r>
              <a:rPr b="0" lang="ja-JP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Grade</a:t>
            </a:r>
            <a:r>
              <a:rPr b="0" lang="ja-JP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II-IV</a:t>
            </a:r>
            <a:r>
              <a:rPr b="0" lang="ja-JP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cases</a:t>
            </a:r>
            <a:r>
              <a:rPr b="0" lang="ja-JP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(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)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102" name=""/>
          <p:cNvGraphicFramePr/>
          <p:nvPr/>
        </p:nvGraphicFramePr>
        <p:xfrm>
          <a:off x="104760" y="2766960"/>
          <a:ext cx="3059280" cy="549360"/>
        </p:xfrm>
        <a:graphic>
          <a:graphicData uri="http://schemas.openxmlformats.org/drawingml/2006/table">
            <a:tbl>
              <a:tblPr/>
              <a:tblGrid>
                <a:gridCol w="766800"/>
                <a:gridCol w="382680"/>
                <a:gridCol w="382320"/>
                <a:gridCol w="381240"/>
                <a:gridCol w="382680"/>
                <a:gridCol w="380880"/>
                <a:gridCol w="382680"/>
              </a:tblGrid>
              <a:tr h="183240">
                <a:tc gridSpan="7"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umber at risk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83240"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methylated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1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1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83240"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unmethylated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61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4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103" name="正方形/長方形 2"/>
          <p:cNvSpPr/>
          <p:nvPr/>
        </p:nvSpPr>
        <p:spPr>
          <a:xfrm>
            <a:off x="316080" y="768240"/>
            <a:ext cx="6467400" cy="23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2560" rIns="52560" tIns="26280" bIns="2628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MGMT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 promoter methylation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statu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04" name="Picture 2" descr=""/>
          <p:cNvPicPr/>
          <p:nvPr/>
        </p:nvPicPr>
        <p:blipFill>
          <a:blip r:embed="rId5"/>
          <a:stretch/>
        </p:blipFill>
        <p:spPr>
          <a:xfrm>
            <a:off x="2135160" y="1201680"/>
            <a:ext cx="838080" cy="277920"/>
          </a:xfrm>
          <a:prstGeom prst="rect">
            <a:avLst/>
          </a:prstGeom>
          <a:ln w="0">
            <a:noFill/>
          </a:ln>
        </p:spPr>
      </p:pic>
      <p:sp>
        <p:nvSpPr>
          <p:cNvPr id="105" name="正方形/長方形 2"/>
          <p:cNvSpPr/>
          <p:nvPr/>
        </p:nvSpPr>
        <p:spPr>
          <a:xfrm>
            <a:off x="2045520" y="1490760"/>
            <a:ext cx="893880" cy="23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52560" rIns="52560" tIns="26280" bIns="2628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p = 0.0129*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6" name="正方形/長方形 18"/>
          <p:cNvSpPr/>
          <p:nvPr/>
        </p:nvSpPr>
        <p:spPr>
          <a:xfrm>
            <a:off x="1465200" y="939960"/>
            <a:ext cx="793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 u="sng">
                <a:solidFill>
                  <a:srgbClr val="000000"/>
                </a:solidFill>
                <a:uFillTx/>
                <a:latin typeface="Arial"/>
                <a:ea typeface="Arial"/>
              </a:rPr>
              <a:t>Grade IV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7" name="正方形/長方形 17"/>
          <p:cNvSpPr/>
          <p:nvPr/>
        </p:nvSpPr>
        <p:spPr>
          <a:xfrm>
            <a:off x="316080" y="3468600"/>
            <a:ext cx="6783120" cy="23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2560" rIns="52560" tIns="26280" bIns="2628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TERT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 promoter mutation status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8" name="正方形/長方形 17"/>
          <p:cNvSpPr/>
          <p:nvPr/>
        </p:nvSpPr>
        <p:spPr>
          <a:xfrm>
            <a:off x="316080" y="6197760"/>
            <a:ext cx="6783120" cy="23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2560" rIns="52560" tIns="26280" bIns="2628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IDH1/2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mutation status                                          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109" name=""/>
          <p:cNvGraphicFramePr/>
          <p:nvPr/>
        </p:nvGraphicFramePr>
        <p:xfrm>
          <a:off x="365040" y="8167680"/>
          <a:ext cx="2808360" cy="549360"/>
        </p:xfrm>
        <a:graphic>
          <a:graphicData uri="http://schemas.openxmlformats.org/drawingml/2006/table">
            <a:tbl>
              <a:tblPr/>
              <a:tblGrid>
                <a:gridCol w="517680"/>
                <a:gridCol w="380880"/>
                <a:gridCol w="382680"/>
                <a:gridCol w="380880"/>
                <a:gridCol w="382680"/>
                <a:gridCol w="380880"/>
                <a:gridCol w="382680"/>
              </a:tblGrid>
              <a:tr h="183240">
                <a:tc gridSpan="7"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umber at risk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83240"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mutated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0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0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83240"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wild-type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27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8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6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</a:tbl>
          </a:graphicData>
        </a:graphic>
      </p:graphicFrame>
      <p:pic>
        <p:nvPicPr>
          <p:cNvPr id="110" name="Picture 2" descr=""/>
          <p:cNvPicPr/>
          <p:nvPr/>
        </p:nvPicPr>
        <p:blipFill>
          <a:blip r:embed="rId6"/>
          <a:stretch/>
        </p:blipFill>
        <p:spPr>
          <a:xfrm>
            <a:off x="2316240" y="6632640"/>
            <a:ext cx="660240" cy="272880"/>
          </a:xfrm>
          <a:prstGeom prst="rect">
            <a:avLst/>
          </a:prstGeom>
          <a:ln w="0">
            <a:noFill/>
          </a:ln>
        </p:spPr>
      </p:pic>
      <p:sp>
        <p:nvSpPr>
          <p:cNvPr id="111" name="正方形/長方形 2"/>
          <p:cNvSpPr/>
          <p:nvPr/>
        </p:nvSpPr>
        <p:spPr>
          <a:xfrm>
            <a:off x="984960" y="7723080"/>
            <a:ext cx="893880" cy="23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52560" rIns="52560" tIns="26280" bIns="2628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p = 0.0003*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2" name="正方形/長方形 18"/>
          <p:cNvSpPr/>
          <p:nvPr/>
        </p:nvSpPr>
        <p:spPr>
          <a:xfrm>
            <a:off x="1611000" y="6340320"/>
            <a:ext cx="92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 u="sng">
                <a:solidFill>
                  <a:srgbClr val="000000"/>
                </a:solidFill>
                <a:uFillTx/>
                <a:latin typeface="Arial"/>
                <a:ea typeface="Arial"/>
              </a:rPr>
              <a:t>Grade II-IV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113" name=""/>
          <p:cNvGraphicFramePr/>
          <p:nvPr/>
        </p:nvGraphicFramePr>
        <p:xfrm>
          <a:off x="3586320" y="5648400"/>
          <a:ext cx="3058920" cy="549360"/>
        </p:xfrm>
        <a:graphic>
          <a:graphicData uri="http://schemas.openxmlformats.org/drawingml/2006/table">
            <a:tbl>
              <a:tblPr/>
              <a:tblGrid>
                <a:gridCol w="766440"/>
                <a:gridCol w="382680"/>
                <a:gridCol w="382680"/>
                <a:gridCol w="380880"/>
                <a:gridCol w="382680"/>
                <a:gridCol w="380880"/>
                <a:gridCol w="382680"/>
              </a:tblGrid>
              <a:tr h="183240">
                <a:tc gridSpan="7"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umber at risk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83240"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mutated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64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6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6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83240"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wild-type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7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7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6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</a:tbl>
          </a:graphicData>
        </a:graphic>
      </p:graphicFrame>
      <p:pic>
        <p:nvPicPr>
          <p:cNvPr id="114" name="Picture 3" descr=""/>
          <p:cNvPicPr/>
          <p:nvPr/>
        </p:nvPicPr>
        <p:blipFill>
          <a:blip r:embed="rId7"/>
          <a:stretch/>
        </p:blipFill>
        <p:spPr>
          <a:xfrm>
            <a:off x="4192560" y="4054320"/>
            <a:ext cx="2306520" cy="1578240"/>
          </a:xfrm>
          <a:prstGeom prst="rect">
            <a:avLst/>
          </a:prstGeom>
          <a:ln w="0">
            <a:noFill/>
          </a:ln>
        </p:spPr>
      </p:pic>
      <p:pic>
        <p:nvPicPr>
          <p:cNvPr id="115" name="Picture 2" descr=""/>
          <p:cNvPicPr/>
          <p:nvPr/>
        </p:nvPicPr>
        <p:blipFill>
          <a:blip r:embed="rId8"/>
          <a:stretch/>
        </p:blipFill>
        <p:spPr>
          <a:xfrm>
            <a:off x="5754600" y="4102200"/>
            <a:ext cx="669960" cy="277560"/>
          </a:xfrm>
          <a:prstGeom prst="rect">
            <a:avLst/>
          </a:prstGeom>
          <a:ln w="0">
            <a:noFill/>
          </a:ln>
        </p:spPr>
      </p:pic>
      <p:sp>
        <p:nvSpPr>
          <p:cNvPr id="116" name="正方形/長方形 2"/>
          <p:cNvSpPr/>
          <p:nvPr/>
        </p:nvSpPr>
        <p:spPr>
          <a:xfrm>
            <a:off x="5505120" y="4416480"/>
            <a:ext cx="893880" cy="23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52560" rIns="52560" tIns="26280" bIns="2628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p = 0.0109*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7" name="正方形/長方形 19"/>
          <p:cNvSpPr/>
          <p:nvPr/>
        </p:nvSpPr>
        <p:spPr>
          <a:xfrm>
            <a:off x="4919760" y="3821040"/>
            <a:ext cx="793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 u="sng">
                <a:solidFill>
                  <a:srgbClr val="000000"/>
                </a:solidFill>
                <a:uFillTx/>
                <a:latin typeface="Arial"/>
                <a:ea typeface="Arial"/>
              </a:rPr>
              <a:t>Grade IV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118" name=""/>
          <p:cNvGraphicFramePr/>
          <p:nvPr/>
        </p:nvGraphicFramePr>
        <p:xfrm>
          <a:off x="3836880" y="8170920"/>
          <a:ext cx="2808360" cy="549360"/>
        </p:xfrm>
        <a:graphic>
          <a:graphicData uri="http://schemas.openxmlformats.org/drawingml/2006/table">
            <a:tbl>
              <a:tblPr/>
              <a:tblGrid>
                <a:gridCol w="517680"/>
                <a:gridCol w="380880"/>
                <a:gridCol w="382680"/>
                <a:gridCol w="380880"/>
                <a:gridCol w="382680"/>
                <a:gridCol w="380880"/>
                <a:gridCol w="382680"/>
              </a:tblGrid>
              <a:tr h="183240">
                <a:tc gridSpan="7"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umber at risk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83240"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mutated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0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0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83240"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wild-type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27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63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9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6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</a:tbl>
          </a:graphicData>
        </a:graphic>
      </p:graphicFrame>
      <p:pic>
        <p:nvPicPr>
          <p:cNvPr id="119" name="Picture 1" descr=""/>
          <p:cNvPicPr/>
          <p:nvPr/>
        </p:nvPicPr>
        <p:blipFill>
          <a:blip r:embed="rId9"/>
          <a:stretch/>
        </p:blipFill>
        <p:spPr>
          <a:xfrm>
            <a:off x="4216320" y="6591240"/>
            <a:ext cx="2306880" cy="1579680"/>
          </a:xfrm>
          <a:prstGeom prst="rect">
            <a:avLst/>
          </a:prstGeom>
          <a:ln w="0">
            <a:noFill/>
          </a:ln>
        </p:spPr>
      </p:pic>
      <p:pic>
        <p:nvPicPr>
          <p:cNvPr id="120" name="Picture 2" descr=""/>
          <p:cNvPicPr/>
          <p:nvPr/>
        </p:nvPicPr>
        <p:blipFill>
          <a:blip r:embed="rId10"/>
          <a:stretch/>
        </p:blipFill>
        <p:spPr>
          <a:xfrm>
            <a:off x="5789520" y="6634080"/>
            <a:ext cx="660600" cy="273240"/>
          </a:xfrm>
          <a:prstGeom prst="rect">
            <a:avLst/>
          </a:prstGeom>
          <a:ln w="0">
            <a:noFill/>
          </a:ln>
        </p:spPr>
      </p:pic>
      <p:sp>
        <p:nvSpPr>
          <p:cNvPr id="121" name="正方形/長方形 2"/>
          <p:cNvSpPr/>
          <p:nvPr/>
        </p:nvSpPr>
        <p:spPr>
          <a:xfrm>
            <a:off x="4458240" y="7726320"/>
            <a:ext cx="893880" cy="23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52560" rIns="52560" tIns="26280" bIns="2628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p = 0.0175*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2" name="正方形/長方形 18"/>
          <p:cNvSpPr/>
          <p:nvPr/>
        </p:nvSpPr>
        <p:spPr>
          <a:xfrm>
            <a:off x="4851000" y="6340320"/>
            <a:ext cx="92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 u="sng">
                <a:solidFill>
                  <a:srgbClr val="000000"/>
                </a:solidFill>
                <a:uFillTx/>
                <a:latin typeface="Arial"/>
                <a:ea typeface="Arial"/>
              </a:rPr>
              <a:t>Grade II-IV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3" name="正方形/長方形 19"/>
          <p:cNvSpPr/>
          <p:nvPr/>
        </p:nvSpPr>
        <p:spPr>
          <a:xfrm>
            <a:off x="1679760" y="3821040"/>
            <a:ext cx="793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 u="sng">
                <a:solidFill>
                  <a:srgbClr val="000000"/>
                </a:solidFill>
                <a:uFillTx/>
                <a:latin typeface="Arial"/>
                <a:ea typeface="Arial"/>
              </a:rPr>
              <a:t>Grade IV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124" name=""/>
          <p:cNvGraphicFramePr/>
          <p:nvPr/>
        </p:nvGraphicFramePr>
        <p:xfrm>
          <a:off x="93600" y="5648400"/>
          <a:ext cx="3059280" cy="549360"/>
        </p:xfrm>
        <a:graphic>
          <a:graphicData uri="http://schemas.openxmlformats.org/drawingml/2006/table">
            <a:tbl>
              <a:tblPr/>
              <a:tblGrid>
                <a:gridCol w="766800"/>
                <a:gridCol w="382680"/>
                <a:gridCol w="382680"/>
                <a:gridCol w="380880"/>
                <a:gridCol w="382680"/>
                <a:gridCol w="380880"/>
                <a:gridCol w="382680"/>
              </a:tblGrid>
              <a:tr h="183240">
                <a:tc gridSpan="7"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umber at risk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83240"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mutated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64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8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83240"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wild-type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7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6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</a:tbl>
          </a:graphicData>
        </a:graphic>
      </p:graphicFrame>
      <p:pic>
        <p:nvPicPr>
          <p:cNvPr id="125" name="Picture 3" descr=""/>
          <p:cNvPicPr/>
          <p:nvPr/>
        </p:nvPicPr>
        <p:blipFill>
          <a:blip r:embed="rId11"/>
          <a:stretch/>
        </p:blipFill>
        <p:spPr>
          <a:xfrm>
            <a:off x="741240" y="4062240"/>
            <a:ext cx="2306880" cy="1578240"/>
          </a:xfrm>
          <a:prstGeom prst="rect">
            <a:avLst/>
          </a:prstGeom>
          <a:ln w="0">
            <a:noFill/>
          </a:ln>
        </p:spPr>
      </p:pic>
      <p:pic>
        <p:nvPicPr>
          <p:cNvPr id="126" name="Picture 2" descr=""/>
          <p:cNvPicPr/>
          <p:nvPr/>
        </p:nvPicPr>
        <p:blipFill>
          <a:blip r:embed="rId12"/>
          <a:stretch/>
        </p:blipFill>
        <p:spPr>
          <a:xfrm>
            <a:off x="2303640" y="4108320"/>
            <a:ext cx="669600" cy="277920"/>
          </a:xfrm>
          <a:prstGeom prst="rect">
            <a:avLst/>
          </a:prstGeom>
          <a:ln w="0">
            <a:noFill/>
          </a:ln>
        </p:spPr>
      </p:pic>
      <p:sp>
        <p:nvSpPr>
          <p:cNvPr id="127" name="正方形/長方形 2"/>
          <p:cNvSpPr/>
          <p:nvPr/>
        </p:nvSpPr>
        <p:spPr>
          <a:xfrm>
            <a:off x="2114640" y="4422600"/>
            <a:ext cx="834480" cy="23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52560" rIns="52560" tIns="26280" bIns="2628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p = 0.6869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8" name="Picture 1" descr=""/>
          <p:cNvPicPr/>
          <p:nvPr/>
        </p:nvPicPr>
        <p:blipFill>
          <a:blip r:embed="rId1"/>
          <a:stretch/>
        </p:blipFill>
        <p:spPr>
          <a:xfrm>
            <a:off x="741240" y="1155600"/>
            <a:ext cx="2306880" cy="1579680"/>
          </a:xfrm>
          <a:prstGeom prst="rect">
            <a:avLst/>
          </a:prstGeom>
          <a:ln w="0">
            <a:noFill/>
          </a:ln>
        </p:spPr>
      </p:pic>
      <p:sp>
        <p:nvSpPr>
          <p:cNvPr id="129" name="正方形/長方形 2"/>
          <p:cNvSpPr/>
          <p:nvPr/>
        </p:nvSpPr>
        <p:spPr>
          <a:xfrm>
            <a:off x="-1440" y="0"/>
            <a:ext cx="7100640" cy="23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2560" rIns="52560" tIns="26280" bIns="2628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Online Resource 7 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Kaplan–Meier survival curves</a:t>
            </a:r>
            <a:r>
              <a:rPr b="0" lang="ja-JP" sz="12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according to WHO</a:t>
            </a:r>
            <a:r>
              <a:rPr b="0" lang="ja-JP" sz="12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Grade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30" name="Picture 1" descr=""/>
          <p:cNvPicPr/>
          <p:nvPr/>
        </p:nvPicPr>
        <p:blipFill>
          <a:blip r:embed="rId2"/>
          <a:stretch/>
        </p:blipFill>
        <p:spPr>
          <a:xfrm>
            <a:off x="4041720" y="1155600"/>
            <a:ext cx="2305080" cy="1579680"/>
          </a:xfrm>
          <a:prstGeom prst="rect">
            <a:avLst/>
          </a:prstGeom>
          <a:ln w="0">
            <a:noFill/>
          </a:ln>
        </p:spPr>
      </p:pic>
      <p:pic>
        <p:nvPicPr>
          <p:cNvPr id="131" name="Picture 2" descr=""/>
          <p:cNvPicPr/>
          <p:nvPr/>
        </p:nvPicPr>
        <p:blipFill>
          <a:blip r:embed="rId3"/>
          <a:stretch/>
        </p:blipFill>
        <p:spPr>
          <a:xfrm>
            <a:off x="5711760" y="1204920"/>
            <a:ext cx="557280" cy="330120"/>
          </a:xfrm>
          <a:prstGeom prst="rect">
            <a:avLst/>
          </a:prstGeom>
          <a:ln w="0">
            <a:noFill/>
          </a:ln>
        </p:spPr>
      </p:pic>
      <p:graphicFrame>
        <p:nvGraphicFramePr>
          <p:cNvPr id="132" name=""/>
          <p:cNvGraphicFramePr/>
          <p:nvPr/>
        </p:nvGraphicFramePr>
        <p:xfrm>
          <a:off x="393840" y="2728800"/>
          <a:ext cx="2808000" cy="731880"/>
        </p:xfrm>
        <a:graphic>
          <a:graphicData uri="http://schemas.openxmlformats.org/drawingml/2006/table">
            <a:tbl>
              <a:tblPr/>
              <a:tblGrid>
                <a:gridCol w="517320"/>
                <a:gridCol w="381240"/>
                <a:gridCol w="382320"/>
                <a:gridCol w="381240"/>
                <a:gridCol w="382320"/>
                <a:gridCol w="381240"/>
                <a:gridCol w="382320"/>
              </a:tblGrid>
              <a:tr h="183240">
                <a:tc gridSpan="7"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umber at risk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83240"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rade II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7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83240"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rade III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8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0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83240"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rade IV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12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4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133" name="正方形/長方形 2"/>
          <p:cNvSpPr/>
          <p:nvPr/>
        </p:nvSpPr>
        <p:spPr>
          <a:xfrm>
            <a:off x="2123640" y="1876320"/>
            <a:ext cx="834480" cy="23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52560" rIns="52560" tIns="26280" bIns="2628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p = 0.1817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134" name=""/>
          <p:cNvGraphicFramePr/>
          <p:nvPr/>
        </p:nvGraphicFramePr>
        <p:xfrm>
          <a:off x="3693960" y="2728800"/>
          <a:ext cx="2808360" cy="731880"/>
        </p:xfrm>
        <a:graphic>
          <a:graphicData uri="http://schemas.openxmlformats.org/drawingml/2006/table">
            <a:tbl>
              <a:tblPr/>
              <a:tblGrid>
                <a:gridCol w="517680"/>
                <a:gridCol w="380880"/>
                <a:gridCol w="382680"/>
                <a:gridCol w="380880"/>
                <a:gridCol w="382680"/>
                <a:gridCol w="380880"/>
                <a:gridCol w="382680"/>
              </a:tblGrid>
              <a:tr h="183240">
                <a:tc gridSpan="7"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umber at risk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83240"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rade II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7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6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83240"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rade III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8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4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9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6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83240"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rade IV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12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3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3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41240"/>
                          <a:tab algn="l" pos="1482840"/>
                          <a:tab algn="l" pos="2224080"/>
                          <a:tab algn="l" pos="2965320"/>
                          <a:tab algn="l" pos="3706920"/>
                          <a:tab algn="l" pos="4448160"/>
                          <a:tab algn="l" pos="5189400"/>
                          <a:tab algn="l" pos="5931000"/>
                          <a:tab algn="l" pos="6672240"/>
                          <a:tab algn="l" pos="7413480"/>
                          <a:tab algn="l" pos="8155080"/>
                          <a:tab algn="l" pos="8896320"/>
                          <a:tab algn="l" pos="9637560"/>
                          <a:tab algn="l" pos="1037916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135" name="正方形/長方形 2"/>
          <p:cNvSpPr/>
          <p:nvPr/>
        </p:nvSpPr>
        <p:spPr>
          <a:xfrm>
            <a:off x="5361840" y="1876320"/>
            <a:ext cx="893880" cy="23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52560" rIns="52560" tIns="26280" bIns="2628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p = 0.0060*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36" name="Picture 2" descr=""/>
          <p:cNvPicPr/>
          <p:nvPr/>
        </p:nvPicPr>
        <p:blipFill>
          <a:blip r:embed="rId4"/>
          <a:stretch/>
        </p:blipFill>
        <p:spPr>
          <a:xfrm>
            <a:off x="2414520" y="1198440"/>
            <a:ext cx="557280" cy="3304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946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11-04T06:18:20Z</dcterms:created>
  <dc:creator>Neurosurgery</dc:creator>
  <dc:description/>
  <dc:language>en-US</dc:language>
  <cp:lastModifiedBy>深井 順也</cp:lastModifiedBy>
  <cp:lastPrinted>2017-04-20T21:40:47Z</cp:lastPrinted>
  <dcterms:modified xsi:type="dcterms:W3CDTF">2018-06-01T01:30:44Z</dcterms:modified>
  <cp:revision>580</cp:revision>
  <dc:subject/>
  <dc:title>PowerPoint プレゼンテーション</dc:title>
</cp:coreProperties>
</file>